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39358-A4D7-4AB9-AF70-0680A76315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A5050-0367-4E91-81E0-A77875CE30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CD1CB-6FE8-4141-82A5-470C8860FC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5E63D-A30E-45D7-888C-F5B5EAE3E0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B3B67-1B98-4F7D-9641-5A09D3E63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3DF92-BFF8-4001-9AE8-6653E4BDCA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238C1-1407-43CE-BD0A-DE225DB36A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71D76-4192-47FA-B521-FC965F7A1B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BC9E5-CFEA-4166-B3CB-C51572AF4E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C0926-8897-4646-A2AA-4CA0C508B4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EB1C1-E7F1-4C4C-AF11-5596FAADAE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8DCAE-B86C-4004-9301-E8B32951CB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23880" y="6244920"/>
            <a:ext cx="60962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17BFC0-A110-473F-ACDC-284C367CE69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44880" y="392040"/>
            <a:ext cx="620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1. 8-mer-only Pairs where Both Proteins are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≥80 Amino Acid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28600" y="838080"/>
            <a:ext cx="8748720" cy="50212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04920" y="5867280"/>
            <a:ext cx="86104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ach row contains information for pairs of sequences that are both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≥80 amino acids in length and that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are an identical 8-amino-acid stretch, but do not share &gt;35% homology over 80 amino acids.  Initial rows in the table show sequence pairs with low-complexity matches falling outside of the FASTA alignment, followed by low-complexity matches within the FASTA alignment.  Next are two sequence matches that only share a 9-amino-acid FASTA sequence alignment.  Finally, ten complex matches within the FASTA alignment are show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Rod Herman</cp:lastModifiedBy>
  <dcterms:modified xsi:type="dcterms:W3CDTF">2009-10-08T11:21:27Z</dcterms:modified>
  <cp:revision>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_Steward">
    <vt:lpwstr>Herman R u098402</vt:lpwstr>
  </property>
  <property fmtid="{D5CDD505-2E9C-101B-9397-08002B2CF9AE}" pid="3" name="Information_Classification">
    <vt:lpwstr>NONE</vt:lpwstr>
  </property>
  <property fmtid="{D5CDD505-2E9C-101B-9397-08002B2CF9AE}" pid="4" name="Initial_Creation_Date">
    <vt:lpwstr/>
  </property>
  <property fmtid="{D5CDD505-2E9C-101B-9397-08002B2CF9AE}" pid="5" name="Last_Reviewed_Date">
    <vt:lpwstr/>
  </property>
  <property fmtid="{D5CDD505-2E9C-101B-9397-08002B2CF9AE}" pid="6" name="Record_Title_ID">
    <vt:lpwstr>72</vt:lpwstr>
  </property>
  <property fmtid="{D5CDD505-2E9C-101B-9397-08002B2CF9AE}" pid="7" name="Retention_Period_Start_Date">
    <vt:lpwstr>8/19/2009</vt:lpwstr>
  </property>
  <property fmtid="{D5CDD505-2E9C-101B-9397-08002B2CF9AE}" pid="8" name="Retention_Review_Frequency">
    <vt:lpwstr/>
  </property>
  <property fmtid="{D5CDD505-2E9C-101B-9397-08002B2CF9AE}" pid="9" name="Version">
    <vt:r8>1</vt:r8>
  </property>
</Properties>
</file>